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4500" cy="9906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78" y="-2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540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6684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5876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72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245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752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3444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561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6839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3666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3358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46FFAE-6BDE-4E2D-96D6-AB09C65CD076}" type="datetimeFigureOut">
              <a:rPr lang="fr-FR" smtClean="0"/>
              <a:pPr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FE6A78-D96D-4F3F-8B78-D774C77746AB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8596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rna.tbi.univie.ac.at/cgi-bin/RNAfold.cgi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http://rna.tbi.univie.ac.at/cgi-bin/IC_helper.cgi?file=/u/html/RNAfold/h7dITUwdki/sequence1_pp.eps&amp;x=452&amp;res=72&amp;ext=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84" b="15287"/>
          <a:stretch>
            <a:fillRect/>
          </a:stretch>
        </p:blipFill>
        <p:spPr bwMode="auto">
          <a:xfrm rot="20688743">
            <a:off x="2320857" y="1725548"/>
            <a:ext cx="2066409" cy="17130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/>
          <a:srcRect l="12201" t="44400" r="63387" b="42300"/>
          <a:stretch>
            <a:fillRect/>
          </a:stretch>
        </p:blipFill>
        <p:spPr bwMode="auto">
          <a:xfrm rot="19018514">
            <a:off x="1112520" y="1085516"/>
            <a:ext cx="2509963" cy="7691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8389" y="4246612"/>
            <a:ext cx="4085850" cy="736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5" descr="http://rna.informatik.uni-freiburg.de:8080/MainServlet?fromPage=fromShowFile&amp;jobID=3465486&amp;toolName=CRISPRmap&amp;fileNameOrType=/StrucDir/StrucClass27/StrucClass27.aln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23"/>
          <a:stretch>
            <a:fillRect/>
          </a:stretch>
        </p:blipFill>
        <p:spPr bwMode="auto">
          <a:xfrm>
            <a:off x="4499992" y="1870656"/>
            <a:ext cx="4427984" cy="2538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Flèche droite 9"/>
          <p:cNvSpPr/>
          <p:nvPr/>
        </p:nvSpPr>
        <p:spPr>
          <a:xfrm>
            <a:off x="4364484" y="2996952"/>
            <a:ext cx="1725309" cy="9034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	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755576" y="2647945"/>
            <a:ext cx="2079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"</a:t>
            </a:r>
            <a:r>
              <a:rPr lang="fr-F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M. intestinalis"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413258" y="712847"/>
            <a:ext cx="1566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"</a:t>
            </a:r>
            <a:r>
              <a:rPr lang="fr-F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M. alvus"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92770" y="1000879"/>
            <a:ext cx="10838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7.95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179512" y="5517232"/>
            <a:ext cx="882047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u="sng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600" b="1" u="sng" dirty="0" smtClean="0">
                <a:latin typeface="Times New Roman" pitchFamily="18" charset="0"/>
                <a:cs typeface="Times New Roman" pitchFamily="18" charset="0"/>
              </a:rPr>
              <a:t> Figure S1</a:t>
            </a:r>
            <a:r>
              <a:rPr lang="fr-FR" sz="16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smtClean="0">
                <a:latin typeface="Times New Roman" pitchFamily="18" charset="0"/>
                <a:ea typeface="Times New Roman"/>
                <a:cs typeface="Times New Roman" pitchFamily="18" charset="0"/>
              </a:rPr>
              <a:t>CRISPR </a:t>
            </a:r>
            <a:r>
              <a:rPr lang="en-US" sz="1600" b="1" dirty="0">
                <a:latin typeface="Times New Roman" pitchFamily="18" charset="0"/>
                <a:ea typeface="Times New Roman"/>
                <a:cs typeface="Times New Roman" pitchFamily="18" charset="0"/>
              </a:rPr>
              <a:t>Direct Repeats </a:t>
            </a:r>
            <a:r>
              <a:rPr lang="en-US" sz="1600" b="1" dirty="0" smtClean="0">
                <a:latin typeface="Times New Roman" pitchFamily="18" charset="0"/>
                <a:ea typeface="Times New Roman"/>
                <a:cs typeface="Times New Roman" pitchFamily="18" charset="0"/>
              </a:rPr>
              <a:t>structures</a:t>
            </a:r>
            <a:endParaRPr lang="en-US" sz="1600" b="1" dirty="0" smtClean="0">
              <a:latin typeface="Times New Roman" pitchFamily="18" charset="0"/>
              <a:ea typeface="Times New Roman"/>
              <a:cs typeface="Times New Roman" pitchFamily="18" charset="0"/>
            </a:endParaRPr>
          </a:p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n the left, 2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Minimum Free Energy structure drawing encoding base-pair probabilities structure of CRISPR DRs retrieved from the 3 genomes of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ethanomassiliicoccale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analyz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using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RNAfol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web server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at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  <a:hlinkClick r:id="rId6"/>
              </a:rPr>
              <a:t>http://rna.tbi.univie.ac.at/cgi-bin/RNAfold.cgi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("</a:t>
            </a:r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Ca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 M. alvus", "</a:t>
            </a:r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Ca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 M. intestinalis" and </a:t>
            </a:r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M</a:t>
            </a:r>
            <a:r>
              <a:rPr lang="fr-FR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 luminyensis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). On the right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sequenc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alignment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 of the DR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retriev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 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"Ca. M. intestinalis"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other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DRs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 Methanococcales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together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the consensu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sequenc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for th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deriv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family3, motif 27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determin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by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CRISPRmap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" name="Picture 6" descr="http://rna.tbi.univie.ac.at/cgi-bin/IC_helper.cgi?file=/u/html/RNAfold/0fwD30G0KF/sequence1_pp.eps&amp;x=452&amp;res=72&amp;ext=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85" t="85366" r="72539" b="9613"/>
          <a:stretch/>
        </p:blipFill>
        <p:spPr bwMode="auto">
          <a:xfrm>
            <a:off x="3275856" y="5013176"/>
            <a:ext cx="1368152" cy="3800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Rectangle 31"/>
          <p:cNvSpPr/>
          <p:nvPr/>
        </p:nvSpPr>
        <p:spPr>
          <a:xfrm>
            <a:off x="4581737" y="1268760"/>
            <a:ext cx="4572000" cy="584775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>
            <a:spAutoFit/>
          </a:bodyPr>
          <a:lstStyle/>
          <a:p>
            <a:r>
              <a:rPr lang="fr-FR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iburg RNA Tools 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fr-FR" sz="1600" b="1" dirty="0" err="1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ISPRmap</a:t>
            </a:r>
            <a:r>
              <a:rPr lang="fr-FR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600" b="1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6991736" y="1445965"/>
            <a:ext cx="1830950" cy="33855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, motif #27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410333">
            <a:off x="1331640" y="3645024"/>
            <a:ext cx="2155979" cy="19037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ZoneTexte 19"/>
          <p:cNvSpPr txBox="1"/>
          <p:nvPr/>
        </p:nvSpPr>
        <p:spPr>
          <a:xfrm>
            <a:off x="395536" y="4077072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 luminyensis</a:t>
            </a:r>
            <a:endParaRPr lang="fr-FR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95536" y="4437112"/>
            <a:ext cx="12250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13.65 kcal/mol</a:t>
            </a:r>
          </a:p>
        </p:txBody>
      </p:sp>
      <p:sp>
        <p:nvSpPr>
          <p:cNvPr id="19" name="Rectangle 18"/>
          <p:cNvSpPr/>
          <p:nvPr/>
        </p:nvSpPr>
        <p:spPr>
          <a:xfrm>
            <a:off x="1187624" y="2935977"/>
            <a:ext cx="108388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.68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0</TotalTime>
  <Words>110</Words>
  <Application>Microsoft Office PowerPoint</Application>
  <PresentationFormat>Affichage à l'écra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F</dc:creator>
  <cp:lastModifiedBy>JF</cp:lastModifiedBy>
  <cp:revision>43</cp:revision>
  <cp:lastPrinted>2013-09-09T08:50:57Z</cp:lastPrinted>
  <dcterms:created xsi:type="dcterms:W3CDTF">2013-04-19T04:18:18Z</dcterms:created>
  <dcterms:modified xsi:type="dcterms:W3CDTF">2014-05-19T21:14:03Z</dcterms:modified>
</cp:coreProperties>
</file>